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63" r:id="rId3"/>
    <p:sldId id="261" r:id="rId4"/>
    <p:sldId id="262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397" autoAdjust="0"/>
    <p:restoredTop sz="94660"/>
  </p:normalViewPr>
  <p:slideViewPr>
    <p:cSldViewPr snapToGrid="0" showGuides="1">
      <p:cViewPr varScale="1">
        <p:scale>
          <a:sx n="50" d="100"/>
          <a:sy n="50" d="100"/>
        </p:scale>
        <p:origin x="2986" y="3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4978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116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17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627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0821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8069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0458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175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357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640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884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F8E74B-2726-4B3B-B43C-C8718953F637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A5CFE2-487D-41B8-9CF7-DA30311ADB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042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4662D68-68ED-3142-7C3F-974A4BB7933A}"/>
              </a:ext>
            </a:extLst>
          </p:cNvPr>
          <p:cNvSpPr txBox="1">
            <a:spLocks/>
          </p:cNvSpPr>
          <p:nvPr/>
        </p:nvSpPr>
        <p:spPr>
          <a:xfrm>
            <a:off x="4795284" y="0"/>
            <a:ext cx="2059461" cy="3349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/>
              <a:t>Supplementary Table 1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xmlns="" id="{6CC37B1C-7716-918C-6659-55911F5F53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0620355"/>
              </p:ext>
            </p:extLst>
          </p:nvPr>
        </p:nvGraphicFramePr>
        <p:xfrm>
          <a:off x="303662" y="1288134"/>
          <a:ext cx="6250673" cy="292513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94101">
                  <a:extLst>
                    <a:ext uri="{9D8B030D-6E8A-4147-A177-3AD203B41FA5}">
                      <a16:colId xmlns:a16="http://schemas.microsoft.com/office/drawing/2014/main" xmlns="" val="2420925053"/>
                    </a:ext>
                  </a:extLst>
                </a:gridCol>
                <a:gridCol w="1194101">
                  <a:extLst>
                    <a:ext uri="{9D8B030D-6E8A-4147-A177-3AD203B41FA5}">
                      <a16:colId xmlns:a16="http://schemas.microsoft.com/office/drawing/2014/main" xmlns="" val="3101938278"/>
                    </a:ext>
                  </a:extLst>
                </a:gridCol>
                <a:gridCol w="1341592">
                  <a:extLst>
                    <a:ext uri="{9D8B030D-6E8A-4147-A177-3AD203B41FA5}">
                      <a16:colId xmlns:a16="http://schemas.microsoft.com/office/drawing/2014/main" xmlns="" val="1044751882"/>
                    </a:ext>
                  </a:extLst>
                </a:gridCol>
                <a:gridCol w="1341592">
                  <a:extLst>
                    <a:ext uri="{9D8B030D-6E8A-4147-A177-3AD203B41FA5}">
                      <a16:colId xmlns:a16="http://schemas.microsoft.com/office/drawing/2014/main" xmlns="" val="1660733593"/>
                    </a:ext>
                  </a:extLst>
                </a:gridCol>
                <a:gridCol w="1179287">
                  <a:extLst>
                    <a:ext uri="{9D8B030D-6E8A-4147-A177-3AD203B41FA5}">
                      <a16:colId xmlns:a16="http://schemas.microsoft.com/office/drawing/2014/main" xmlns="" val="2146630421"/>
                    </a:ext>
                  </a:extLst>
                </a:gridCol>
              </a:tblGrid>
              <a:tr h="417876">
                <a:tc rowSpan="2"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Group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Glomerular score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Tubular score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Tubule\interstitial score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Endothelial score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3698969491"/>
                  </a:ext>
                </a:extLst>
              </a:tr>
              <a:tr h="2089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0    1    2    3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0    1    2    3    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0    1    2    3    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0    1    2    3    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3205041426"/>
                  </a:ext>
                </a:extLst>
              </a:tr>
              <a:tr h="41787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Sham control group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10   -    -     -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10   -    -     -    -   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10   -    -     -     -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10   -    -     -     -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3700275051"/>
                  </a:ext>
                </a:extLst>
              </a:tr>
              <a:tr h="41787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Folic acid-treated group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10   -    -     -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10   -    -     -    -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10   -    -     -     -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10   -    -     -     -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4200501245"/>
                  </a:ext>
                </a:extLst>
              </a:tr>
              <a:tr h="62681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Ischemia reperfusion group 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-     2    7    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-     1    2     7   -    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-      1   3    6    -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-     8    1    1    -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924842730"/>
                  </a:ext>
                </a:extLst>
              </a:tr>
              <a:tr h="83575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>
                          <a:effectLst/>
                        </a:rPr>
                        <a:t>Folic acid and ischemia reperfusion group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7    2    1      -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-    8    1     1   -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-      9   1   -    - 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</a:rPr>
                        <a:t>8     1    1     -   -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350652189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5AFAB457-6AD4-69CE-178E-5A9835AE0D87}"/>
              </a:ext>
            </a:extLst>
          </p:cNvPr>
          <p:cNvSpPr txBox="1"/>
          <p:nvPr/>
        </p:nvSpPr>
        <p:spPr>
          <a:xfrm>
            <a:off x="148339" y="4609899"/>
            <a:ext cx="6561317" cy="62939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17145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tabLst>
                <a:tab pos="5143500" algn="l"/>
                <a:tab pos="6286500" algn="l"/>
              </a:tabLst>
            </a:pPr>
            <a:r>
              <a:rPr lang="en-US" sz="1200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1:  Table S1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: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Histopathological scores of renal changes in 10 sections examined from different studied groups. In each group, we reported the number of sections showing each score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17145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tabLst>
                <a:tab pos="5143500" algn="l"/>
                <a:tab pos="6286500" algn="l"/>
              </a:tabLs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) Glomerular score: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17145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tabLst>
                <a:tab pos="5143500" algn="l"/>
                <a:tab pos="6286500" algn="l"/>
              </a:tabLs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0: no damage. 1: Thickening of the Bowman capsule. 2: retraction of glomerular tuft. 3: Glomerular fibrosis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17145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tabLst>
                <a:tab pos="5143500" algn="l"/>
                <a:tab pos="6286500" algn="l"/>
              </a:tabLs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b) Tubular score: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17145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tabLst>
                <a:tab pos="5143500" algn="l"/>
                <a:tab pos="6286500" algn="l"/>
              </a:tabLs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0: no damage. 1: loss of brush border (BB) in less than 25% of tubules and intact basement membrane. 2: loss of BB in more than 25% of tubules, thickened basement membrane. 3: (plus) inflammation, cast formation and necrosis in up to 60% of tubular cells. 4: (plus)necrosis in more than 60% of tubular cells.</a:t>
            </a:r>
            <a:b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)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ubulo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\ interstitial score: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17145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tabLst>
                <a:tab pos="5143500" algn="l"/>
                <a:tab pos="6286500" algn="l"/>
              </a:tabLs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0: no damage. 1: inflammation and hemorrhage in less than 25% of tissue. 2: (plus) necrosis in less than 25% of tissue. 3: (plus) necrosis up to 60%. 4: necrosis in more than 60% of the tissue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17145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tabLst>
                <a:tab pos="5143500" algn="l"/>
                <a:tab pos="6286500" algn="l"/>
              </a:tabLs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) Endothelial score: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  <a:p>
            <a:pPr marL="0" marR="17145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  <a:tabLst>
                <a:tab pos="5143500" algn="l"/>
                <a:tab pos="6286500" algn="l"/>
              </a:tabLs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0: no damage. 1: endothelial swelling. 2: endothelial disruption. 3: endothelial loss.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7600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47351569"/>
              </p:ext>
            </p:extLst>
          </p:nvPr>
        </p:nvGraphicFramePr>
        <p:xfrm>
          <a:off x="2127107" y="1623869"/>
          <a:ext cx="2388202" cy="248400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9410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19410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41787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+mn-ea"/>
                        </a:rPr>
                        <a:t>Constituents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</a:rPr>
                        <a:t>Weight (g)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5118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+mn-ea"/>
                        </a:rPr>
                        <a:t>Protein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</a:rPr>
                        <a:t>0.20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1474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</a:rPr>
                        <a:t>Carbohydrates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</a:rPr>
                        <a:t>0.77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3552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</a:rPr>
                        <a:t>Fat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</a:rPr>
                        <a:t>0.03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4245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</a:rPr>
                        <a:t>Calcium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</a:rPr>
                        <a:t>0.012</a:t>
                      </a:r>
                      <a:endParaRPr lang="en-US" sz="1200" dirty="0">
                        <a:effectLst/>
                        <a:latin typeface="+mn-lt"/>
                        <a:ea typeface="Times New Roman" panose="02020603050405020304" pitchFamily="18" charset="0"/>
                      </a:endParaRP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5631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Phosphates</a:t>
                      </a: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27709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Sodium</a:t>
                      </a: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0.021</a:t>
                      </a: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29094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Potassium</a:t>
                      </a: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29787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Total</a:t>
                      </a:r>
                    </a:p>
                  </a:txBody>
                  <a:tcPr marL="65824" marR="65824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1200"/>
                        </a:spcBef>
                        <a:spcAft>
                          <a:spcPts val="600"/>
                        </a:spcAft>
                      </a:pPr>
                      <a:r>
                        <a:rPr lang="en-US" sz="1200" dirty="0">
                          <a:effectLst/>
                          <a:latin typeface="+mn-lt"/>
                          <a:ea typeface="Times New Roman" panose="02020603050405020304" pitchFamily="18" charset="0"/>
                        </a:rPr>
                        <a:t>1 g</a:t>
                      </a:r>
                    </a:p>
                  </a:txBody>
                  <a:tcPr marL="65824" marR="65824" marT="0" marB="0"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699727" y="4277539"/>
            <a:ext cx="572060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1:  Table S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: 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composition of the standard rat chow diet used in our study</a:t>
            </a: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xmlns="" id="{E692FF7A-6E23-C41A-8CAC-F0628104B0B2}"/>
              </a:ext>
            </a:extLst>
          </p:cNvPr>
          <p:cNvSpPr txBox="1">
            <a:spLocks/>
          </p:cNvSpPr>
          <p:nvPr/>
        </p:nvSpPr>
        <p:spPr>
          <a:xfrm>
            <a:off x="4795284" y="0"/>
            <a:ext cx="2059461" cy="3349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/>
              <a:t>Supplementary Table 2 </a:t>
            </a:r>
          </a:p>
        </p:txBody>
      </p:sp>
    </p:spTree>
    <p:extLst>
      <p:ext uri="{BB962C8B-B14F-4D97-AF65-F5344CB8AC3E}">
        <p14:creationId xmlns:p14="http://schemas.microsoft.com/office/powerpoint/2010/main" val="13926730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8A57486-541A-58B2-6518-74D89E95171D}"/>
              </a:ext>
            </a:extLst>
          </p:cNvPr>
          <p:cNvSpPr txBox="1">
            <a:spLocks/>
          </p:cNvSpPr>
          <p:nvPr/>
        </p:nvSpPr>
        <p:spPr>
          <a:xfrm>
            <a:off x="4708478" y="0"/>
            <a:ext cx="2146267" cy="3349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/>
              <a:t>Supplementary figure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F628CBFC-D2E1-2C35-5CCD-ABCD616451BF}"/>
              </a:ext>
            </a:extLst>
          </p:cNvPr>
          <p:cNvSpPr txBox="1"/>
          <p:nvPr/>
        </p:nvSpPr>
        <p:spPr>
          <a:xfrm>
            <a:off x="253314" y="6296899"/>
            <a:ext cx="6351372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17145" algn="just">
              <a:lnSpc>
                <a:spcPct val="200000"/>
              </a:lnSpc>
              <a:tabLst>
                <a:tab pos="5143500" algn="l"/>
                <a:tab pos="6286500" algn="l"/>
              </a:tabLst>
            </a:pPr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1: Figure S1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-D):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hotomicrographs of renal cortex of different studied groups (Masson’s Trichrome x400): Sham group: showing few collagen fibers between glomerular capillaries (*), surrounding renal corpuscle (↑) and between the renal tubules (▲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(A)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A group: showing few collagen fibers between glomerular capillaries (*), surrounding renal corpuscle (↑) and between the renal tubules (▲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(B)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R group: showing increased collagen fibers between glomerular capillaries (*), surrounding renal corpuscle (↑) and in between renal tubules (▲). Increased collagen deposition in the lumen of some tubules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(*) (C)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A-IR group: showing a mild increase in collagen fibers between glomerular capillaries (*), few collagen fibers surrounding the renal corpuscle (↑) and between renal tubules (▲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(D). Scale bar is 50 µm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314" y="500234"/>
            <a:ext cx="2982487" cy="2664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314" y="2879481"/>
            <a:ext cx="304800" cy="2857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5490" y="529086"/>
            <a:ext cx="3082664" cy="26361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69541" y="2854081"/>
            <a:ext cx="328613" cy="311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314" y="3257892"/>
            <a:ext cx="2982487" cy="2664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314" y="5624732"/>
            <a:ext cx="304800" cy="323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6" name="Picture 8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5490" y="3249050"/>
            <a:ext cx="3082664" cy="2628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7" name="Picture 9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15130" y="5556590"/>
            <a:ext cx="418162" cy="342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475129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E062737-4285-7BD9-64D1-DE10EFFA92F5}"/>
              </a:ext>
            </a:extLst>
          </p:cNvPr>
          <p:cNvSpPr txBox="1">
            <a:spLocks/>
          </p:cNvSpPr>
          <p:nvPr/>
        </p:nvSpPr>
        <p:spPr>
          <a:xfrm>
            <a:off x="4708478" y="0"/>
            <a:ext cx="2146267" cy="334962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/>
              <a:t>Supplementary figure 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B36EBBA5-695B-5152-C92F-D83C30697CC1}"/>
              </a:ext>
            </a:extLst>
          </p:cNvPr>
          <p:cNvSpPr txBox="1"/>
          <p:nvPr/>
        </p:nvSpPr>
        <p:spPr>
          <a:xfrm>
            <a:off x="91300" y="5830748"/>
            <a:ext cx="6681750" cy="34163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17145" algn="just">
              <a:lnSpc>
                <a:spcPct val="200000"/>
              </a:lnSpc>
              <a:spcBef>
                <a:spcPts val="600"/>
              </a:spcBef>
              <a:spcAft>
                <a:spcPts val="600"/>
              </a:spcAft>
              <a:tabLst>
                <a:tab pos="5143500" algn="l"/>
                <a:tab pos="6286500" algn="l"/>
              </a:tabLs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dditional file 1: </a:t>
            </a:r>
            <a:r>
              <a:rPr lang="en-US" sz="1200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igure S2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-D):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hotomicrographs of the renal cortex of different studied groups (PAS x 400). Sham group: PAS-positive brush border of cells lining PCTs (↑), the basement membrane of renal tubules (blue arrow) and the parietal layer of the Bowman capsule (red arrow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(A)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A group: PAS-positive brush border of cells lining PCTs (↑), the basement membrane of renal tubules (blue arrow) and the parietal layer of the Bowman capsule (red arrow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(B)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IR group: showing loss of brush border of cells of PCTs (↑), the basement membrane of the tubules (blue arrow) and the parietal layer of Bowman capsule (red arrow) showing increased positive PAS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reaction (C). 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FA-IR group: showing focally interrupted PAS-positive brush border in most of the PCTs (↑), PAS-positive basement membrane of the tubules (blue arrow) and parietal layer of Bowman capsule (red arrow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(D). Scale bar is 50 µm.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748" y="633193"/>
            <a:ext cx="2951822" cy="24423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4145" y="630633"/>
            <a:ext cx="2951822" cy="24423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748" y="3182831"/>
            <a:ext cx="2951822" cy="24423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4145" y="3182831"/>
            <a:ext cx="2951822" cy="24423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748" y="2792982"/>
            <a:ext cx="304800" cy="282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8942" y="2777900"/>
            <a:ext cx="327025" cy="31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748" y="5340831"/>
            <a:ext cx="304800" cy="3206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8941" y="5328332"/>
            <a:ext cx="327025" cy="2968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387283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</TotalTime>
  <Words>661</Words>
  <Application>Microsoft Office PowerPoint</Application>
  <PresentationFormat>Widescreen</PresentationFormat>
  <Paragraphs>6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rif mohamed diaa eldin  mahmoud</dc:creator>
  <cp:lastModifiedBy>Jasmine Mohammed Hidayath</cp:lastModifiedBy>
  <cp:revision>10</cp:revision>
  <dcterms:created xsi:type="dcterms:W3CDTF">2023-06-30T17:42:45Z</dcterms:created>
  <dcterms:modified xsi:type="dcterms:W3CDTF">2024-01-25T05:34:00Z</dcterms:modified>
</cp:coreProperties>
</file>